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90" autoAdjust="0"/>
    <p:restoredTop sz="94660"/>
  </p:normalViewPr>
  <p:slideViewPr>
    <p:cSldViewPr>
      <p:cViewPr>
        <p:scale>
          <a:sx n="90" d="100"/>
          <a:sy n="90" d="100"/>
        </p:scale>
        <p:origin x="-1267" y="-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1420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786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7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2402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8851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332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9025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5511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13632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5657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00566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05605-DB5A-4140-8A82-4768180E65C6}" type="datetimeFigureOut">
              <a:rPr lang="it-IT" smtClean="0"/>
              <a:t>04/04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92571-3A1A-456F-B305-E0F9709982C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6076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00;p2"/>
          <p:cNvSpPr txBox="1"/>
          <p:nvPr/>
        </p:nvSpPr>
        <p:spPr>
          <a:xfrm>
            <a:off x="-4464" y="-13371"/>
            <a:ext cx="9148464" cy="9232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 smtClean="0">
                <a:solidFill>
                  <a:srgbClr val="FF0000"/>
                </a:solidFill>
                <a:latin typeface="Calibri"/>
                <a:cs typeface="Calibri"/>
                <a:sym typeface="Calibri"/>
              </a:rPr>
              <a:t>CATALASE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oading order:</a:t>
            </a:r>
            <a:endParaRPr dirty="0"/>
          </a:p>
          <a:p>
            <a:endParaRPr lang="en-US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  <p:sp>
        <p:nvSpPr>
          <p:cNvPr id="5" name="Google Shape;101;p2"/>
          <p:cNvSpPr txBox="1"/>
          <p:nvPr/>
        </p:nvSpPr>
        <p:spPr>
          <a:xfrm>
            <a:off x="-1" y="4108063"/>
            <a:ext cx="89958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 smtClean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CATALASE  </a:t>
            </a:r>
            <a:endParaRPr dirty="0"/>
          </a:p>
        </p:txBody>
      </p:sp>
      <p:cxnSp>
        <p:nvCxnSpPr>
          <p:cNvPr id="6" name="Google Shape;102;p2"/>
          <p:cNvCxnSpPr/>
          <p:nvPr/>
        </p:nvCxnSpPr>
        <p:spPr>
          <a:xfrm>
            <a:off x="3027986" y="823893"/>
            <a:ext cx="31846" cy="4898330"/>
          </a:xfrm>
          <a:prstGeom prst="straightConnector1">
            <a:avLst/>
          </a:prstGeom>
          <a:noFill/>
          <a:ln w="38100" cap="flat" cmpd="sng">
            <a:solidFill>
              <a:srgbClr val="002060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7" name="Google Shape;103;p2"/>
          <p:cNvSpPr txBox="1"/>
          <p:nvPr/>
        </p:nvSpPr>
        <p:spPr>
          <a:xfrm>
            <a:off x="35250" y="1727085"/>
            <a:ext cx="110810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β-ACTIN</a:t>
            </a:r>
            <a:endParaRPr dirty="0"/>
          </a:p>
        </p:txBody>
      </p:sp>
      <p:sp>
        <p:nvSpPr>
          <p:cNvPr id="25" name="TextBox 24"/>
          <p:cNvSpPr txBox="1"/>
          <p:nvPr/>
        </p:nvSpPr>
        <p:spPr>
          <a:xfrm>
            <a:off x="35250" y="654616"/>
            <a:ext cx="2771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0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/</a:t>
            </a:r>
            <a:r>
              <a:rPr lang="en-US" sz="1000" b="1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pLV+5µM 6-OHDA/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+5µM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0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10 µM 6-OHDA/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10 µM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 </a:t>
            </a:r>
            <a:r>
              <a:rPr lang="en-US" sz="10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6-OHDA/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6-OHDA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027986" y="823893"/>
            <a:ext cx="60776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/</a:t>
            </a:r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400" b="1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pLV-URG7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+20µM 6-OHDA/ pLV-URG7 +20µM 6-OHDA</a:t>
            </a:r>
          </a:p>
        </p:txBody>
      </p:sp>
      <p:pic>
        <p:nvPicPr>
          <p:cNvPr id="1026" name="Picture 2" descr="C:\Users\ilari\Desktop\DOTTORATO\URG7\WB\wb 5-1-23\catalasi 6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9" t="33267" r="8615" b="28872"/>
          <a:stretch/>
        </p:blipFill>
        <p:spPr bwMode="auto">
          <a:xfrm>
            <a:off x="142392" y="4509120"/>
            <a:ext cx="2862876" cy="9352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9" name="Straight Arrow Connector 28"/>
          <p:cNvCxnSpPr/>
          <p:nvPr/>
        </p:nvCxnSpPr>
        <p:spPr>
          <a:xfrm>
            <a:off x="-169315" y="5129404"/>
            <a:ext cx="250912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7" name="Picture 3" descr="C:\Users\ilari\Desktop\DOTTORATO\URG7\WB\wb 16-6-23\12%\actina_Exposure_1.0sec OK 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9992" y="1498405"/>
            <a:ext cx="2592288" cy="19361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ilari\Desktop\DOTTORATO\URG7\WB\wb 16-6-23\12%\CATALASI_Exposure_16.1sec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6572" y="3815918"/>
            <a:ext cx="2602472" cy="194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532" r="4352" b="32027"/>
          <a:stretch/>
        </p:blipFill>
        <p:spPr>
          <a:xfrm>
            <a:off x="142392" y="2204864"/>
            <a:ext cx="2732288" cy="880533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9983748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100;p2"/>
          <p:cNvSpPr txBox="1"/>
          <p:nvPr/>
        </p:nvSpPr>
        <p:spPr>
          <a:xfrm>
            <a:off x="-4464" y="-13371"/>
            <a:ext cx="9148464" cy="9232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 smtClean="0">
                <a:solidFill>
                  <a:srgbClr val="FF0000"/>
                </a:solidFill>
                <a:latin typeface="Calibri"/>
                <a:cs typeface="Calibri"/>
                <a:sym typeface="Calibri"/>
              </a:rPr>
              <a:t>SOD2</a:t>
            </a:r>
            <a:endParaRPr dirty="0" smtClean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oading 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rder:</a:t>
            </a:r>
            <a:endParaRPr dirty="0"/>
          </a:p>
          <a:p>
            <a:endParaRPr lang="en-US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  <p:pic>
        <p:nvPicPr>
          <p:cNvPr id="2050" name="Picture 2" descr="F:\DOTTORATO\URG7\WB\wb 13-7-23\sod 39.0 sc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950"/>
          <a:stretch/>
        </p:blipFill>
        <p:spPr bwMode="auto">
          <a:xfrm>
            <a:off x="5195995" y="4015237"/>
            <a:ext cx="3147054" cy="25815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283968" y="732076"/>
            <a:ext cx="46841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 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/</a:t>
            </a:r>
            <a:r>
              <a:rPr lang="en-US" sz="12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 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200" b="1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2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pLV-URG7/</a:t>
            </a:r>
            <a:r>
              <a:rPr lang="en-US" sz="12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+20µM 6-OHDA/ pLV-URG7 +20µM 6-OHDA</a:t>
            </a:r>
          </a:p>
        </p:txBody>
      </p:sp>
      <p:sp>
        <p:nvSpPr>
          <p:cNvPr id="5" name="Google Shape;101;p2"/>
          <p:cNvSpPr txBox="1"/>
          <p:nvPr/>
        </p:nvSpPr>
        <p:spPr>
          <a:xfrm>
            <a:off x="35250" y="3717032"/>
            <a:ext cx="89958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 smtClean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SOD2 </a:t>
            </a:r>
            <a:endParaRPr dirty="0"/>
          </a:p>
        </p:txBody>
      </p:sp>
      <p:sp>
        <p:nvSpPr>
          <p:cNvPr id="6" name="Google Shape;103;p2"/>
          <p:cNvSpPr txBox="1"/>
          <p:nvPr/>
        </p:nvSpPr>
        <p:spPr>
          <a:xfrm>
            <a:off x="35250" y="1727085"/>
            <a:ext cx="110810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β-ACTIN</a:t>
            </a:r>
            <a:endParaRPr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0072" y="1476090"/>
            <a:ext cx="3147054" cy="2362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" name="Google Shape;102;p2"/>
          <p:cNvCxnSpPr/>
          <p:nvPr/>
        </p:nvCxnSpPr>
        <p:spPr>
          <a:xfrm>
            <a:off x="4067944" y="1139576"/>
            <a:ext cx="31846" cy="4898330"/>
          </a:xfrm>
          <a:prstGeom prst="straightConnector1">
            <a:avLst/>
          </a:prstGeom>
          <a:noFill/>
          <a:ln w="38100" cap="flat" cmpd="sng">
            <a:solidFill>
              <a:srgbClr val="002060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9" name="TextBox 8"/>
          <p:cNvSpPr txBox="1"/>
          <p:nvPr/>
        </p:nvSpPr>
        <p:spPr>
          <a:xfrm>
            <a:off x="46750" y="785633"/>
            <a:ext cx="358914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/</a:t>
            </a:r>
            <a:r>
              <a:rPr lang="en-US" sz="1200" b="1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pLV+5µM 6-OHDA/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+5µM 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2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10 µM 6-OHDA/ 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10 µM 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 </a:t>
            </a:r>
            <a:r>
              <a:rPr lang="en-US" sz="12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6-OHDA/ </a:t>
            </a:r>
            <a:r>
              <a:rPr lang="en-US" sz="12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2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6-OHDA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532" r="4352" b="32027"/>
          <a:stretch/>
        </p:blipFill>
        <p:spPr>
          <a:xfrm>
            <a:off x="485045" y="2218266"/>
            <a:ext cx="2732288" cy="880533"/>
          </a:xfrm>
          <a:prstGeom prst="rect">
            <a:avLst/>
          </a:prstGeom>
          <a:ln>
            <a:noFill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12" t="41885" r="4485" b="29057"/>
          <a:stretch/>
        </p:blipFill>
        <p:spPr bwMode="auto">
          <a:xfrm>
            <a:off x="466871" y="4583744"/>
            <a:ext cx="2981918" cy="7222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020685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00;p2"/>
          <p:cNvSpPr txBox="1"/>
          <p:nvPr/>
        </p:nvSpPr>
        <p:spPr>
          <a:xfrm>
            <a:off x="-4464" y="-13371"/>
            <a:ext cx="9148464" cy="9232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 smtClean="0">
                <a:solidFill>
                  <a:srgbClr val="FF0000"/>
                </a:solidFill>
                <a:latin typeface="Calibri"/>
                <a:cs typeface="Calibri"/>
                <a:sym typeface="Calibri"/>
              </a:rPr>
              <a:t>NRF2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oading order:</a:t>
            </a:r>
            <a:endParaRPr dirty="0"/>
          </a:p>
          <a:p>
            <a:endParaRPr lang="en-US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  <p:sp>
        <p:nvSpPr>
          <p:cNvPr id="5" name="Google Shape;101;p2"/>
          <p:cNvSpPr txBox="1"/>
          <p:nvPr/>
        </p:nvSpPr>
        <p:spPr>
          <a:xfrm>
            <a:off x="-4464" y="3969563"/>
            <a:ext cx="89958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 smtClean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NRF2  </a:t>
            </a:r>
            <a:endParaRPr dirty="0"/>
          </a:p>
        </p:txBody>
      </p:sp>
      <p:cxnSp>
        <p:nvCxnSpPr>
          <p:cNvPr id="6" name="Google Shape;102;p2"/>
          <p:cNvCxnSpPr/>
          <p:nvPr/>
        </p:nvCxnSpPr>
        <p:spPr>
          <a:xfrm>
            <a:off x="3203848" y="1722420"/>
            <a:ext cx="15923" cy="4223818"/>
          </a:xfrm>
          <a:prstGeom prst="straightConnector1">
            <a:avLst/>
          </a:prstGeom>
          <a:noFill/>
          <a:ln w="38100" cap="flat" cmpd="sng">
            <a:solidFill>
              <a:srgbClr val="002060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7" name="Google Shape;103;p2"/>
          <p:cNvSpPr txBox="1"/>
          <p:nvPr/>
        </p:nvSpPr>
        <p:spPr>
          <a:xfrm>
            <a:off x="35250" y="1727085"/>
            <a:ext cx="110810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β-ACTIN</a:t>
            </a:r>
            <a:endParaRPr dirty="0"/>
          </a:p>
        </p:txBody>
      </p:sp>
      <p:sp>
        <p:nvSpPr>
          <p:cNvPr id="26" name="TextBox 25"/>
          <p:cNvSpPr txBox="1"/>
          <p:nvPr/>
        </p:nvSpPr>
        <p:spPr>
          <a:xfrm>
            <a:off x="3066323" y="764704"/>
            <a:ext cx="60776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/</a:t>
            </a:r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400" b="1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pLV-URG7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+20µM 6-OHDA/ pLV-URG7 +20µM 6-OHDA</a:t>
            </a: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004" b="17201"/>
          <a:stretch/>
        </p:blipFill>
        <p:spPr bwMode="auto">
          <a:xfrm>
            <a:off x="207255" y="4739950"/>
            <a:ext cx="1872208" cy="15582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7" name="Straight Arrow Connector 16"/>
          <p:cNvCxnSpPr/>
          <p:nvPr/>
        </p:nvCxnSpPr>
        <p:spPr>
          <a:xfrm>
            <a:off x="-90206" y="5373216"/>
            <a:ext cx="250912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90" t="32904" r="48343" b="39841"/>
          <a:stretch/>
        </p:blipFill>
        <p:spPr bwMode="auto">
          <a:xfrm>
            <a:off x="226020" y="2288335"/>
            <a:ext cx="1853444" cy="8334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8" t="19749" r="118" b="30266"/>
          <a:stretch/>
        </p:blipFill>
        <p:spPr bwMode="auto">
          <a:xfrm>
            <a:off x="4287136" y="4653136"/>
            <a:ext cx="3623996" cy="13529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35250" y="764704"/>
            <a:ext cx="29994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/</a:t>
            </a:r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</a:p>
          <a:p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</a:t>
            </a:r>
            <a:endParaRPr lang="en-US" sz="1400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  <p:pic>
        <p:nvPicPr>
          <p:cNvPr id="21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7984" y="1659579"/>
            <a:ext cx="3147054" cy="2362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738139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734" b="26592"/>
          <a:stretch/>
        </p:blipFill>
        <p:spPr bwMode="auto">
          <a:xfrm>
            <a:off x="1435864" y="3933056"/>
            <a:ext cx="6412804" cy="2427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Google Shape;100;p2"/>
          <p:cNvSpPr txBox="1"/>
          <p:nvPr/>
        </p:nvSpPr>
        <p:spPr>
          <a:xfrm>
            <a:off x="-4464" y="-13371"/>
            <a:ext cx="9148464" cy="9232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 smtClean="0">
                <a:solidFill>
                  <a:srgbClr val="FF0000"/>
                </a:solidFill>
                <a:latin typeface="Calibri"/>
                <a:cs typeface="Calibri"/>
                <a:sym typeface="Calibri"/>
              </a:rPr>
              <a:t>PINK1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oading order:</a:t>
            </a:r>
            <a:endParaRPr dirty="0"/>
          </a:p>
          <a:p>
            <a:endParaRPr lang="en-US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0" y="760971"/>
            <a:ext cx="9144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/</a:t>
            </a:r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400" b="1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pLV-URG7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+20µM 6-OHDA/ pLV-URG7 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400" b="1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pLV-URG7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+20µM 6-OHDA/ pLV-URG7 +20µM 6-OHDA</a:t>
            </a:r>
          </a:p>
          <a:p>
            <a:pPr algn="ctr"/>
            <a:endParaRPr lang="en-US" sz="1400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  <p:sp>
        <p:nvSpPr>
          <p:cNvPr id="5" name="Google Shape;101;p2"/>
          <p:cNvSpPr txBox="1"/>
          <p:nvPr/>
        </p:nvSpPr>
        <p:spPr>
          <a:xfrm>
            <a:off x="0" y="3501008"/>
            <a:ext cx="89958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 smtClean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INK1  </a:t>
            </a:r>
            <a:endParaRPr dirty="0"/>
          </a:p>
        </p:txBody>
      </p:sp>
      <p:sp>
        <p:nvSpPr>
          <p:cNvPr id="6" name="Google Shape;103;p2"/>
          <p:cNvSpPr txBox="1"/>
          <p:nvPr/>
        </p:nvSpPr>
        <p:spPr>
          <a:xfrm>
            <a:off x="35250" y="1727085"/>
            <a:ext cx="110810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β-ACTIN</a:t>
            </a:r>
            <a:endParaRPr dirty="0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5" t="32431" r="6617" b="34513"/>
          <a:stretch/>
        </p:blipFill>
        <p:spPr bwMode="auto">
          <a:xfrm>
            <a:off x="1691680" y="1730330"/>
            <a:ext cx="5400600" cy="14936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" name="Straight Arrow Connector 7"/>
          <p:cNvCxnSpPr/>
          <p:nvPr/>
        </p:nvCxnSpPr>
        <p:spPr>
          <a:xfrm>
            <a:off x="971600" y="5373216"/>
            <a:ext cx="629837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408492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100;p2"/>
          <p:cNvSpPr txBox="1"/>
          <p:nvPr/>
        </p:nvSpPr>
        <p:spPr>
          <a:xfrm>
            <a:off x="-4464" y="-13371"/>
            <a:ext cx="9148464" cy="9232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 smtClean="0">
                <a:solidFill>
                  <a:srgbClr val="FF0000"/>
                </a:solidFill>
                <a:latin typeface="Calibri"/>
                <a:cs typeface="Calibri"/>
                <a:sym typeface="Calibri"/>
              </a:rPr>
              <a:t>PARKIN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oading order:</a:t>
            </a:r>
            <a:endParaRPr dirty="0"/>
          </a:p>
          <a:p>
            <a:endParaRPr lang="en-US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  <p:sp>
        <p:nvSpPr>
          <p:cNvPr id="3" name="Google Shape;101;p2"/>
          <p:cNvSpPr txBox="1"/>
          <p:nvPr/>
        </p:nvSpPr>
        <p:spPr>
          <a:xfrm>
            <a:off x="0" y="3501008"/>
            <a:ext cx="89958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 smtClean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ARKIN  </a:t>
            </a:r>
            <a:endParaRPr dirty="0"/>
          </a:p>
        </p:txBody>
      </p:sp>
      <p:sp>
        <p:nvSpPr>
          <p:cNvPr id="4" name="Google Shape;103;p2"/>
          <p:cNvSpPr txBox="1"/>
          <p:nvPr/>
        </p:nvSpPr>
        <p:spPr>
          <a:xfrm>
            <a:off x="-4464" y="1756415"/>
            <a:ext cx="110810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β-ACTIN</a:t>
            </a:r>
            <a:endParaRPr dirty="0"/>
          </a:p>
        </p:txBody>
      </p:sp>
      <p:cxnSp>
        <p:nvCxnSpPr>
          <p:cNvPr id="5" name="Google Shape;102;p2"/>
          <p:cNvCxnSpPr/>
          <p:nvPr/>
        </p:nvCxnSpPr>
        <p:spPr>
          <a:xfrm>
            <a:off x="4644008" y="1461011"/>
            <a:ext cx="15923" cy="4223818"/>
          </a:xfrm>
          <a:prstGeom prst="straightConnector1">
            <a:avLst/>
          </a:prstGeom>
          <a:noFill/>
          <a:ln w="38100" cap="flat" cmpd="sng">
            <a:solidFill>
              <a:srgbClr val="002060"/>
            </a:solidFill>
            <a:prstDash val="solid"/>
            <a:round/>
            <a:headEnd type="none" w="sm" len="sm"/>
            <a:tailEnd type="none" w="sm" len="sm"/>
          </a:ln>
        </p:spPr>
      </p:cxn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4088" y="4148158"/>
            <a:ext cx="3277996" cy="24482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309"/>
          <a:stretch/>
        </p:blipFill>
        <p:spPr>
          <a:xfrm>
            <a:off x="5324219" y="1617767"/>
            <a:ext cx="3047280" cy="1280429"/>
          </a:xfrm>
          <a:prstGeom prst="rect">
            <a:avLst/>
          </a:prstGeom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507" y="4148158"/>
            <a:ext cx="3138141" cy="23455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1756415"/>
            <a:ext cx="3202310" cy="23917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-4464" y="819289"/>
            <a:ext cx="4572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/</a:t>
            </a:r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400" b="1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pLV-URG7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+20µM 6-OHDA/ pLV-URG7 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400" b="1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pLV-URG7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+20µM 6-OHDA/ pLV-URG7 +20µM 6-OHDA</a:t>
            </a:r>
          </a:p>
          <a:p>
            <a:pPr algn="ctr"/>
            <a:endParaRPr lang="en-US" sz="1400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662568" y="819289"/>
            <a:ext cx="4572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/</a:t>
            </a:r>
            <a:r>
              <a:rPr lang="en-US" sz="14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 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400" b="1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MARKERS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pLV-URG7/</a:t>
            </a:r>
            <a:r>
              <a:rPr lang="en-US" sz="14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4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+20µM 6-OHDA/ pLV-URG7 +20µM </a:t>
            </a:r>
            <a:r>
              <a:rPr lang="en-US" sz="14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</a:t>
            </a:r>
            <a:endParaRPr lang="en-US" sz="1400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066034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24749" y="1045762"/>
            <a:ext cx="9108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0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/ pLV-URG7/MARKERS/ </a:t>
            </a:r>
            <a:r>
              <a:rPr lang="en-US" sz="1000" dirty="0" err="1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+5µM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+5µM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</a:t>
            </a:r>
            <a:r>
              <a:rPr lang="en-US" sz="10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10 µM 6-OHDA/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10 µM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6-OHDA/ </a:t>
            </a:r>
            <a:r>
              <a:rPr lang="en-US" sz="1000" dirty="0" err="1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+20µM 6-OHDA/ </a:t>
            </a:r>
            <a:r>
              <a:rPr lang="en-US" sz="1000" dirty="0" smtClean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 </a:t>
            </a:r>
            <a:r>
              <a:rPr lang="en-US" sz="1000" dirty="0">
                <a:solidFill>
                  <a:schemeClr val="dk1"/>
                </a:solidFill>
                <a:ea typeface="Calibri"/>
                <a:cs typeface="Calibri"/>
                <a:sym typeface="Calibri"/>
              </a:rPr>
              <a:t>pLV-URG7 +20µM 6-OHDA</a:t>
            </a:r>
          </a:p>
        </p:txBody>
      </p:sp>
      <p:sp>
        <p:nvSpPr>
          <p:cNvPr id="3" name="Google Shape;100;p2"/>
          <p:cNvSpPr txBox="1"/>
          <p:nvPr/>
        </p:nvSpPr>
        <p:spPr>
          <a:xfrm>
            <a:off x="-4464" y="-13371"/>
            <a:ext cx="9148464" cy="9232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 smtClean="0">
                <a:solidFill>
                  <a:srgbClr val="FF0000"/>
                </a:solidFill>
                <a:latin typeface="Calibri"/>
                <a:cs typeface="Calibri"/>
                <a:sym typeface="Calibri"/>
              </a:rPr>
              <a:t>DJ-1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oading order:</a:t>
            </a:r>
            <a:endParaRPr dirty="0"/>
          </a:p>
          <a:p>
            <a:endParaRPr lang="en-US" dirty="0">
              <a:solidFill>
                <a:schemeClr val="dk1"/>
              </a:solidFill>
              <a:ea typeface="Calibri"/>
              <a:cs typeface="Calibri"/>
              <a:sym typeface="Calibri"/>
            </a:endParaRPr>
          </a:p>
        </p:txBody>
      </p:sp>
      <p:sp>
        <p:nvSpPr>
          <p:cNvPr id="4" name="Google Shape;101;p2"/>
          <p:cNvSpPr txBox="1"/>
          <p:nvPr/>
        </p:nvSpPr>
        <p:spPr>
          <a:xfrm>
            <a:off x="0" y="3656057"/>
            <a:ext cx="89958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 smtClean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DJ-1  </a:t>
            </a:r>
            <a:endParaRPr dirty="0"/>
          </a:p>
        </p:txBody>
      </p:sp>
      <p:sp>
        <p:nvSpPr>
          <p:cNvPr id="5" name="Google Shape;103;p2"/>
          <p:cNvSpPr txBox="1"/>
          <p:nvPr/>
        </p:nvSpPr>
        <p:spPr>
          <a:xfrm>
            <a:off x="18452" y="1495817"/>
            <a:ext cx="1108109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β-ACTIN</a:t>
            </a:r>
            <a:endParaRPr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7824" y="4221088"/>
            <a:ext cx="2699526" cy="20162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" name="Google Shape;102;p2"/>
          <p:cNvCxnSpPr/>
          <p:nvPr/>
        </p:nvCxnSpPr>
        <p:spPr>
          <a:xfrm>
            <a:off x="2627784" y="1708313"/>
            <a:ext cx="15923" cy="4223818"/>
          </a:xfrm>
          <a:prstGeom prst="straightConnector1">
            <a:avLst/>
          </a:prstGeom>
          <a:noFill/>
          <a:ln w="38100" cap="flat" cmpd="sng">
            <a:solidFill>
              <a:srgbClr val="002060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8" name="Google Shape;102;p2"/>
          <p:cNvCxnSpPr/>
          <p:nvPr/>
        </p:nvCxnSpPr>
        <p:spPr>
          <a:xfrm>
            <a:off x="6300192" y="1682647"/>
            <a:ext cx="15923" cy="4223818"/>
          </a:xfrm>
          <a:prstGeom prst="straightConnector1">
            <a:avLst/>
          </a:prstGeom>
          <a:noFill/>
          <a:ln w="38100" cap="flat" cmpd="sng">
            <a:solidFill>
              <a:srgbClr val="002060"/>
            </a:solidFill>
            <a:prstDash val="solid"/>
            <a:round/>
            <a:headEnd type="none" w="sm" len="sm"/>
            <a:tailEnd type="none" w="sm" len="sm"/>
          </a:ln>
        </p:spPr>
      </p:cxn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149080"/>
            <a:ext cx="2506704" cy="1872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586" y="1780108"/>
            <a:ext cx="2304118" cy="1720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2" y="1780108"/>
            <a:ext cx="2699526" cy="20162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7761" y="1708313"/>
            <a:ext cx="2560338" cy="19122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2811" y="4227953"/>
            <a:ext cx="2390238" cy="17852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35030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9</TotalTime>
  <Words>273</Words>
  <Application>Microsoft Office PowerPoint</Application>
  <PresentationFormat>On-screen Show (4:3)</PresentationFormat>
  <Paragraphs>35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laria</dc:creator>
  <cp:lastModifiedBy>ilaria</cp:lastModifiedBy>
  <cp:revision>44</cp:revision>
  <dcterms:created xsi:type="dcterms:W3CDTF">2024-06-19T21:24:29Z</dcterms:created>
  <dcterms:modified xsi:type="dcterms:W3CDTF">2025-04-04T14:47:56Z</dcterms:modified>
</cp:coreProperties>
</file>